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9" d="100"/>
          <a:sy n="109" d="100"/>
        </p:scale>
        <p:origin x="1596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F0A24-8514-4CF0-A281-358CB7EC8E5B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8E81A-409C-41F1-9720-F32CE99B2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4249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F0A24-8514-4CF0-A281-358CB7EC8E5B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8E81A-409C-41F1-9720-F32CE99B2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515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F0A24-8514-4CF0-A281-358CB7EC8E5B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8E81A-409C-41F1-9720-F32CE99B2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1926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F0A24-8514-4CF0-A281-358CB7EC8E5B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8E81A-409C-41F1-9720-F32CE99B2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973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F0A24-8514-4CF0-A281-358CB7EC8E5B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8E81A-409C-41F1-9720-F32CE99B2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7370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F0A24-8514-4CF0-A281-358CB7EC8E5B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8E81A-409C-41F1-9720-F32CE99B2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48423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F0A24-8514-4CF0-A281-358CB7EC8E5B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8E81A-409C-41F1-9720-F32CE99B2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781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F0A24-8514-4CF0-A281-358CB7EC8E5B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8E81A-409C-41F1-9720-F32CE99B2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68324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F0A24-8514-4CF0-A281-358CB7EC8E5B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8E81A-409C-41F1-9720-F32CE99B2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8643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F0A24-8514-4CF0-A281-358CB7EC8E5B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8E81A-409C-41F1-9720-F32CE99B2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57617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CF0A24-8514-4CF0-A281-358CB7EC8E5B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8E81A-409C-41F1-9720-F32CE99B2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315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CF0A24-8514-4CF0-A281-358CB7EC8E5B}" type="datetimeFigureOut">
              <a:rPr lang="en-US" smtClean="0"/>
              <a:t>2/2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08E81A-409C-41F1-9720-F32CE99B2F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096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23336842"/>
              </p:ext>
            </p:extLst>
          </p:nvPr>
        </p:nvGraphicFramePr>
        <p:xfrm>
          <a:off x="571954" y="736820"/>
          <a:ext cx="8114847" cy="6100520"/>
        </p:xfrm>
        <a:graphic>
          <a:graphicData uri="http://schemas.openxmlformats.org/drawingml/2006/table">
            <a:tbl>
              <a:tblPr/>
              <a:tblGrid>
                <a:gridCol w="206787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51501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8950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54245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t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hemical Name</a:t>
                      </a:r>
                    </a:p>
                  </a:txBody>
                  <a:tcPr marL="8140" marR="8140" marT="8140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athway Name</a:t>
                      </a:r>
                    </a:p>
                  </a:txBody>
                  <a:tcPr marL="8140" marR="8140" marT="8140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IP Score</a:t>
                      </a:r>
                    </a:p>
                  </a:txBody>
                  <a:tcPr marL="8140" marR="8140" marT="8140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hr-Englerin / 24hr-Control</a:t>
                      </a:r>
                    </a:p>
                  </a:txBody>
                  <a:tcPr marL="8140" marR="8140" marT="8140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8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C(18:1/22:0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nglioside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380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8.885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C(18:1/24:1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nglioside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803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9.633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C(18:1/20:0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nglioside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549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.416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ramide(d18:1/25:0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phing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76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.308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ramide(d18:1/24:0 OH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phingolipid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00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567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ramide(d18:1/24:1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phing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82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601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L(18:2/18:1/18:1/20:4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ardiolipin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590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22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ytidine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yrimidine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65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302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C(18:1/16:0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nglioside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54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249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pt-BR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ramide(d18:1/18:0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phing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06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009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M(16:1 OH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phing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93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82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G(44:12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hosph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74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85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M(18:1 OH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phing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73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85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M(16:0 OH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phing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62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87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G(34:1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hosph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91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98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M(18:2 OH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phing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63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03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C(28:1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hosph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51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05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M(d18:1/16:0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phing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11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12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M(16:2 OH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phing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38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24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M(d18:1/18:1(9Z)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phing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06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30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ICAR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urine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83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262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holesterol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holesterol, Cortisol, Non-Gonadal Stero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36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100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E(34:2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hosph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30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45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C(30:0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hosph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21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47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M(22:0 OH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phing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11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49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C(30:2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hosph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11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49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M(d18:1/16:1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phing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85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54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M(d18:1/20:2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phing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55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61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C(16:0/18:1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hosph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24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67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yrophosphate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hosphate and Pyrophosphate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78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77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M(d18:1/22:1(13Z)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phing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71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79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M(d18:1/24:1(15Z)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phing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57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82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C(34:1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hosph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53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83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G(40:8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hosph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26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89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C(24:0/P-18:0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hosph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14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92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1502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M(20:1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phing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10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93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15876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C(28:0)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hospholipid Metabolism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10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93</a:t>
                      </a:r>
                    </a:p>
                  </a:txBody>
                  <a:tcPr marL="8140" marR="8140" marT="814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</a:tbl>
          </a:graphicData>
        </a:graphic>
      </p:graphicFrame>
      <p:sp>
        <p:nvSpPr>
          <p:cNvPr id="3" name="Title 5"/>
          <p:cNvSpPr txBox="1">
            <a:spLocks/>
          </p:cNvSpPr>
          <p:nvPr/>
        </p:nvSpPr>
        <p:spPr>
          <a:xfrm>
            <a:off x="457200" y="274638"/>
            <a:ext cx="8229600" cy="510657"/>
          </a:xfrm>
          <a:prstGeom prst="rect">
            <a:avLst/>
          </a:prstGeom>
        </p:spPr>
        <p:txBody>
          <a:bodyPr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200" dirty="0"/>
              <a:t>S1 Table. Top Metabolites Changed by Englerin Treatment for 24 h</a:t>
            </a:r>
          </a:p>
        </p:txBody>
      </p:sp>
    </p:spTree>
    <p:extLst>
      <p:ext uri="{BB962C8B-B14F-4D97-AF65-F5344CB8AC3E}">
        <p14:creationId xmlns:p14="http://schemas.microsoft.com/office/powerpoint/2010/main" val="13328155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253</Words>
  <Application>Microsoft Office PowerPoint</Application>
  <PresentationFormat>On-screen Show (4:3)</PresentationFormat>
  <Paragraphs>15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CSD Pediatric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tova, Ayse</dc:creator>
  <cp:lastModifiedBy>James Zapf</cp:lastModifiedBy>
  <cp:revision>7</cp:revision>
  <dcterms:created xsi:type="dcterms:W3CDTF">2016-08-03T02:33:50Z</dcterms:created>
  <dcterms:modified xsi:type="dcterms:W3CDTF">2017-02-27T21:55:51Z</dcterms:modified>
</cp:coreProperties>
</file>